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107997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ACD49B-BB82-4F93-B91F-20056F2B7C1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431280"/>
            <a:ext cx="61722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520720"/>
            <a:ext cx="61722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6243840"/>
            <a:ext cx="61722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133743-062C-45AB-B7A2-B226C8F9CF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431280"/>
            <a:ext cx="61722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520720"/>
            <a:ext cx="30117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520720"/>
            <a:ext cx="30117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6243840"/>
            <a:ext cx="30117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6243840"/>
            <a:ext cx="30117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2DC542-80BB-48D5-9CF0-8B570E719D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431280"/>
            <a:ext cx="61722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520720"/>
            <a:ext cx="19872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520720"/>
            <a:ext cx="19872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520720"/>
            <a:ext cx="19872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6243840"/>
            <a:ext cx="19872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6243840"/>
            <a:ext cx="19872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6243840"/>
            <a:ext cx="19872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B2F307-9D02-46F8-8822-6B856FE909E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431280"/>
            <a:ext cx="61722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520720"/>
            <a:ext cx="6172200" cy="7127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65B579-1A3B-4C51-B7EA-88CFE46317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431280"/>
            <a:ext cx="61722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520720"/>
            <a:ext cx="6172200" cy="712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2703F6-F84A-4E4F-B42E-2FD2864A1F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431280"/>
            <a:ext cx="61722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520720"/>
            <a:ext cx="3011760" cy="712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520720"/>
            <a:ext cx="3011760" cy="712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28298A-810B-421D-8DF5-55667D8B5D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431280"/>
            <a:ext cx="61722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BC0326-69EE-4986-8C84-C0F8FA5067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431280"/>
            <a:ext cx="6172200" cy="8346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F52697-1D93-4965-B942-C6BAA03BDB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431280"/>
            <a:ext cx="61722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520720"/>
            <a:ext cx="30117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520720"/>
            <a:ext cx="3011760" cy="712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6243840"/>
            <a:ext cx="30117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8A246E-EABD-4881-BA93-4EFEAA6D8A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431280"/>
            <a:ext cx="61722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520720"/>
            <a:ext cx="3011760" cy="712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520720"/>
            <a:ext cx="30117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6243840"/>
            <a:ext cx="30117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17CFFE-ED81-4F62-A470-13F475EE3A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431280"/>
            <a:ext cx="61722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520720"/>
            <a:ext cx="30117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520720"/>
            <a:ext cx="301176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6243840"/>
            <a:ext cx="6172200" cy="339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F98617-B13C-496B-A7CB-393D2E7B08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431280"/>
            <a:ext cx="6172200" cy="18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520720"/>
            <a:ext cx="6172200" cy="712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10010880"/>
            <a:ext cx="1600200" cy="57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10010880"/>
            <a:ext cx="2171520" cy="57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10010880"/>
            <a:ext cx="1600200" cy="57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98711A-57F5-4002-9880-88B76056A95E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531720" y="977760"/>
          <a:ext cx="6858000" cy="9633240"/>
        </p:xfrm>
        <a:graphic>
          <a:graphicData uri="http://schemas.openxmlformats.org/drawingml/2006/table">
            <a:tbl>
              <a:tblPr/>
              <a:tblGrid>
                <a:gridCol w="2286000"/>
                <a:gridCol w="2195640"/>
                <a:gridCol w="2376360"/>
              </a:tblGrid>
              <a:tr h="1605240">
                <a:tc>
                  <a:txBody>
                    <a:bodyPr lIns="54720" rIns="54720" tIns="29160" bIns="291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. thalian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4720" marR="54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720" rIns="54720" tIns="29160" bIns="291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. papay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4720" marR="54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220760"/>
                          <a:tab algn="l" pos="2441520"/>
                          <a:tab algn="l" pos="3662280"/>
                          <a:tab algn="l" pos="4883040"/>
                          <a:tab algn="l" pos="6103800"/>
                          <a:tab algn="l" pos="7324560"/>
                          <a:tab algn="l" pos="8545680"/>
                          <a:tab algn="l" pos="976644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. vinifer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220760"/>
                          <a:tab algn="l" pos="2441520"/>
                          <a:tab algn="l" pos="3662280"/>
                          <a:tab algn="l" pos="4883040"/>
                          <a:tab algn="l" pos="6103800"/>
                          <a:tab algn="l" pos="7324560"/>
                          <a:tab algn="l" pos="8545680"/>
                          <a:tab algn="l" pos="976644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6320">
                <a:tc>
                  <a:txBody>
                    <a:bodyPr lIns="54720" rIns="54720" tIns="29160" bIns="291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. esculent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4720" marR="54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720" rIns="54720" tIns="29160" bIns="291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. communis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4720" marR="54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220760"/>
                          <a:tab algn="l" pos="2441520"/>
                          <a:tab algn="l" pos="3662280"/>
                          <a:tab algn="l" pos="4883040"/>
                          <a:tab algn="l" pos="6103800"/>
                          <a:tab algn="l" pos="7324560"/>
                          <a:tab algn="l" pos="8545680"/>
                          <a:tab algn="l" pos="976644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488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220760"/>
                          <a:tab algn="l" pos="2441520"/>
                          <a:tab algn="l" pos="3662280"/>
                          <a:tab algn="l" pos="4883040"/>
                          <a:tab algn="l" pos="6103800"/>
                          <a:tab algn="l" pos="7324560"/>
                          <a:tab algn="l" pos="8545680"/>
                          <a:tab algn="l" pos="976644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. sativus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220760"/>
                          <a:tab algn="l" pos="2441520"/>
                          <a:tab algn="l" pos="3662280"/>
                          <a:tab algn="l" pos="4883040"/>
                          <a:tab algn="l" pos="6103800"/>
                          <a:tab algn="l" pos="7324560"/>
                          <a:tab algn="l" pos="8545680"/>
                          <a:tab algn="l" pos="976644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. vesc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220760"/>
                          <a:tab algn="l" pos="2441520"/>
                          <a:tab algn="l" pos="3662280"/>
                          <a:tab algn="l" pos="4883040"/>
                          <a:tab algn="l" pos="6103800"/>
                          <a:tab algn="l" pos="7324560"/>
                          <a:tab algn="l" pos="8545680"/>
                          <a:tab algn="l" pos="976644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. trichocarp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220760"/>
                          <a:tab algn="l" pos="2441520"/>
                          <a:tab algn="l" pos="3662280"/>
                          <a:tab algn="l" pos="4883040"/>
                          <a:tab algn="l" pos="6103800"/>
                          <a:tab algn="l" pos="7324560"/>
                          <a:tab algn="l" pos="8545680"/>
                          <a:tab algn="l" pos="976644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24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220760"/>
                          <a:tab algn="l" pos="2441520"/>
                          <a:tab algn="l" pos="3662280"/>
                          <a:tab algn="l" pos="4883040"/>
                          <a:tab algn="l" pos="6103800"/>
                          <a:tab algn="l" pos="7324560"/>
                          <a:tab algn="l" pos="8545680"/>
                          <a:tab algn="l" pos="976644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. japonicus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720" rIns="54720" tIns="29160" bIns="291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. max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4720" marR="54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720" rIns="54720" tIns="29160" bIns="291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220760"/>
                          <a:tab algn="l" pos="2441520"/>
                          <a:tab algn="l" pos="3662280"/>
                          <a:tab algn="l" pos="4883040"/>
                          <a:tab algn="l" pos="6103800"/>
                          <a:tab algn="l" pos="7324560"/>
                          <a:tab algn="l" pos="8545680"/>
                          <a:tab algn="l" pos="976644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. truncatul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220760"/>
                          <a:tab algn="l" pos="2441520"/>
                          <a:tab algn="l" pos="3662280"/>
                          <a:tab algn="l" pos="4883040"/>
                          <a:tab algn="l" pos="6103800"/>
                          <a:tab algn="l" pos="7324560"/>
                          <a:tab algn="l" pos="8545680"/>
                          <a:tab algn="l" pos="976644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4720" marR="54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6320">
                <a:tc>
                  <a:txBody>
                    <a:bodyPr lIns="54720" rIns="54720" tIns="29160" bIns="291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. lycopersicum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4720" marR="54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720" rIns="54720" tIns="29160" bIns="291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. tuberosum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4720" marR="54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220760"/>
                          <a:tab algn="l" pos="2441520"/>
                          <a:tab algn="l" pos="3662280"/>
                          <a:tab algn="l" pos="4883040"/>
                          <a:tab algn="l" pos="6103800"/>
                          <a:tab algn="l" pos="7324560"/>
                          <a:tab algn="l" pos="8545680"/>
                          <a:tab algn="l" pos="976644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. distachyo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220760"/>
                          <a:tab algn="l" pos="2441520"/>
                          <a:tab algn="l" pos="3662280"/>
                          <a:tab algn="l" pos="4883040"/>
                          <a:tab algn="l" pos="6103800"/>
                          <a:tab algn="l" pos="7324560"/>
                          <a:tab algn="l" pos="8545680"/>
                          <a:tab algn="l" pos="976644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240">
                <a:tc>
                  <a:txBody>
                    <a:bodyPr lIns="54720" rIns="54720" tIns="29160" bIns="291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. sativ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4720" marR="54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720" rIns="54720" tIns="29160" bIns="291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. mays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4720" marR="54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720" rIns="54720" tIns="29160" bIns="291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. bicolor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54720" marR="54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42" name="グラフ 2" descr=""/>
          <p:cNvPicPr/>
          <p:nvPr/>
        </p:nvPicPr>
        <p:blipFill>
          <a:blip r:embed="rId1"/>
          <a:stretch/>
        </p:blipFill>
        <p:spPr>
          <a:xfrm>
            <a:off x="219240" y="1158840"/>
            <a:ext cx="2347920" cy="1230480"/>
          </a:xfrm>
          <a:prstGeom prst="rect">
            <a:avLst/>
          </a:prstGeom>
          <a:ln w="0">
            <a:noFill/>
          </a:ln>
        </p:spPr>
      </p:pic>
      <p:pic>
        <p:nvPicPr>
          <p:cNvPr id="43" name="グラフ 3" descr=""/>
          <p:cNvPicPr/>
          <p:nvPr/>
        </p:nvPicPr>
        <p:blipFill>
          <a:blip r:embed="rId2"/>
          <a:stretch/>
        </p:blipFill>
        <p:spPr>
          <a:xfrm>
            <a:off x="4584600" y="4376880"/>
            <a:ext cx="2346480" cy="1231920"/>
          </a:xfrm>
          <a:prstGeom prst="rect">
            <a:avLst/>
          </a:prstGeom>
          <a:ln w="0">
            <a:noFill/>
          </a:ln>
        </p:spPr>
      </p:pic>
      <p:pic>
        <p:nvPicPr>
          <p:cNvPr id="44" name="グラフ 4" descr=""/>
          <p:cNvPicPr/>
          <p:nvPr/>
        </p:nvPicPr>
        <p:blipFill>
          <a:blip r:embed="rId3"/>
          <a:stretch/>
        </p:blipFill>
        <p:spPr>
          <a:xfrm>
            <a:off x="219240" y="2755800"/>
            <a:ext cx="2347920" cy="1230480"/>
          </a:xfrm>
          <a:prstGeom prst="rect">
            <a:avLst/>
          </a:prstGeom>
          <a:ln w="0">
            <a:noFill/>
          </a:ln>
        </p:spPr>
      </p:pic>
      <p:pic>
        <p:nvPicPr>
          <p:cNvPr id="45" name="グラフ 5" descr=""/>
          <p:cNvPicPr/>
          <p:nvPr/>
        </p:nvPicPr>
        <p:blipFill>
          <a:blip r:embed="rId4"/>
          <a:stretch/>
        </p:blipFill>
        <p:spPr>
          <a:xfrm>
            <a:off x="2419200" y="7601040"/>
            <a:ext cx="2341800" cy="1225440"/>
          </a:xfrm>
          <a:prstGeom prst="rect">
            <a:avLst/>
          </a:prstGeom>
          <a:ln w="0">
            <a:noFill/>
          </a:ln>
        </p:spPr>
      </p:pic>
      <p:pic>
        <p:nvPicPr>
          <p:cNvPr id="46" name="グラフ 6" descr=""/>
          <p:cNvPicPr/>
          <p:nvPr/>
        </p:nvPicPr>
        <p:blipFill>
          <a:blip r:embed="rId5"/>
          <a:stretch/>
        </p:blipFill>
        <p:spPr>
          <a:xfrm>
            <a:off x="2419200" y="5979960"/>
            <a:ext cx="2341800" cy="1231920"/>
          </a:xfrm>
          <a:prstGeom prst="rect">
            <a:avLst/>
          </a:prstGeom>
          <a:ln w="0">
            <a:noFill/>
          </a:ln>
        </p:spPr>
      </p:pic>
      <p:pic>
        <p:nvPicPr>
          <p:cNvPr id="47" name="グラフ 7" descr=""/>
          <p:cNvPicPr/>
          <p:nvPr/>
        </p:nvPicPr>
        <p:blipFill>
          <a:blip r:embed="rId6"/>
          <a:stretch/>
        </p:blipFill>
        <p:spPr>
          <a:xfrm>
            <a:off x="2419200" y="4376880"/>
            <a:ext cx="2341800" cy="1231920"/>
          </a:xfrm>
          <a:prstGeom prst="rect">
            <a:avLst/>
          </a:prstGeom>
          <a:ln w="0">
            <a:noFill/>
          </a:ln>
        </p:spPr>
      </p:pic>
      <p:pic>
        <p:nvPicPr>
          <p:cNvPr id="48" name="グラフ 8" descr=""/>
          <p:cNvPicPr/>
          <p:nvPr/>
        </p:nvPicPr>
        <p:blipFill>
          <a:blip r:embed="rId7"/>
          <a:stretch/>
        </p:blipFill>
        <p:spPr>
          <a:xfrm>
            <a:off x="4584600" y="7601040"/>
            <a:ext cx="2346480" cy="1225440"/>
          </a:xfrm>
          <a:prstGeom prst="rect">
            <a:avLst/>
          </a:prstGeom>
          <a:ln w="0">
            <a:noFill/>
          </a:ln>
        </p:spPr>
      </p:pic>
      <p:pic>
        <p:nvPicPr>
          <p:cNvPr id="49" name="グラフ 9" descr=""/>
          <p:cNvPicPr/>
          <p:nvPr/>
        </p:nvPicPr>
        <p:blipFill>
          <a:blip r:embed="rId8"/>
          <a:stretch/>
        </p:blipFill>
        <p:spPr>
          <a:xfrm>
            <a:off x="4584600" y="5979960"/>
            <a:ext cx="2346480" cy="1231920"/>
          </a:xfrm>
          <a:prstGeom prst="rect">
            <a:avLst/>
          </a:prstGeom>
          <a:ln w="0">
            <a:noFill/>
          </a:ln>
        </p:spPr>
      </p:pic>
      <p:pic>
        <p:nvPicPr>
          <p:cNvPr id="50" name="グラフ 10" descr=""/>
          <p:cNvPicPr/>
          <p:nvPr/>
        </p:nvPicPr>
        <p:blipFill>
          <a:blip r:embed="rId9"/>
          <a:stretch/>
        </p:blipFill>
        <p:spPr>
          <a:xfrm>
            <a:off x="2419200" y="2755800"/>
            <a:ext cx="2341800" cy="1230480"/>
          </a:xfrm>
          <a:prstGeom prst="rect">
            <a:avLst/>
          </a:prstGeom>
          <a:ln w="0">
            <a:noFill/>
          </a:ln>
        </p:spPr>
      </p:pic>
      <p:pic>
        <p:nvPicPr>
          <p:cNvPr id="51" name="グラフ 11" descr=""/>
          <p:cNvPicPr/>
          <p:nvPr/>
        </p:nvPicPr>
        <p:blipFill>
          <a:blip r:embed="rId10"/>
          <a:stretch/>
        </p:blipFill>
        <p:spPr>
          <a:xfrm>
            <a:off x="219240" y="7601040"/>
            <a:ext cx="2347920" cy="1225440"/>
          </a:xfrm>
          <a:prstGeom prst="rect">
            <a:avLst/>
          </a:prstGeom>
          <a:ln w="0">
            <a:noFill/>
          </a:ln>
        </p:spPr>
      </p:pic>
      <p:pic>
        <p:nvPicPr>
          <p:cNvPr id="52" name="グラフ 12" descr=""/>
          <p:cNvPicPr/>
          <p:nvPr/>
        </p:nvPicPr>
        <p:blipFill>
          <a:blip r:embed="rId11"/>
          <a:stretch/>
        </p:blipFill>
        <p:spPr>
          <a:xfrm>
            <a:off x="2419200" y="9163080"/>
            <a:ext cx="2341800" cy="1224000"/>
          </a:xfrm>
          <a:prstGeom prst="rect">
            <a:avLst/>
          </a:prstGeom>
          <a:ln w="0">
            <a:noFill/>
          </a:ln>
        </p:spPr>
      </p:pic>
      <p:pic>
        <p:nvPicPr>
          <p:cNvPr id="53" name="グラフ 13" descr=""/>
          <p:cNvPicPr/>
          <p:nvPr/>
        </p:nvPicPr>
        <p:blipFill>
          <a:blip r:embed="rId12"/>
          <a:stretch/>
        </p:blipFill>
        <p:spPr>
          <a:xfrm>
            <a:off x="219240" y="9150480"/>
            <a:ext cx="2347920" cy="1231920"/>
          </a:xfrm>
          <a:prstGeom prst="rect">
            <a:avLst/>
          </a:prstGeom>
          <a:ln w="0">
            <a:noFill/>
          </a:ln>
        </p:spPr>
      </p:pic>
      <p:pic>
        <p:nvPicPr>
          <p:cNvPr id="54" name="グラフ 14" descr=""/>
          <p:cNvPicPr/>
          <p:nvPr/>
        </p:nvPicPr>
        <p:blipFill>
          <a:blip r:embed="rId13"/>
          <a:stretch/>
        </p:blipFill>
        <p:spPr>
          <a:xfrm>
            <a:off x="219240" y="5979960"/>
            <a:ext cx="2347920" cy="1231920"/>
          </a:xfrm>
          <a:prstGeom prst="rect">
            <a:avLst/>
          </a:prstGeom>
          <a:ln w="0">
            <a:noFill/>
          </a:ln>
        </p:spPr>
      </p:pic>
      <p:pic>
        <p:nvPicPr>
          <p:cNvPr id="55" name="グラフ 15" descr=""/>
          <p:cNvPicPr/>
          <p:nvPr/>
        </p:nvPicPr>
        <p:blipFill>
          <a:blip r:embed="rId14"/>
          <a:stretch/>
        </p:blipFill>
        <p:spPr>
          <a:xfrm>
            <a:off x="2419200" y="1158840"/>
            <a:ext cx="2341800" cy="1230480"/>
          </a:xfrm>
          <a:prstGeom prst="rect">
            <a:avLst/>
          </a:prstGeom>
          <a:ln w="0">
            <a:noFill/>
          </a:ln>
        </p:spPr>
      </p:pic>
      <p:pic>
        <p:nvPicPr>
          <p:cNvPr id="56" name="グラフ 16" descr=""/>
          <p:cNvPicPr/>
          <p:nvPr/>
        </p:nvPicPr>
        <p:blipFill>
          <a:blip r:embed="rId15"/>
          <a:stretch/>
        </p:blipFill>
        <p:spPr>
          <a:xfrm>
            <a:off x="4578480" y="1158840"/>
            <a:ext cx="2346120" cy="1230480"/>
          </a:xfrm>
          <a:prstGeom prst="rect">
            <a:avLst/>
          </a:prstGeom>
          <a:ln w="0">
            <a:noFill/>
          </a:ln>
        </p:spPr>
      </p:pic>
      <p:pic>
        <p:nvPicPr>
          <p:cNvPr id="57" name="グラフ 17" descr=""/>
          <p:cNvPicPr/>
          <p:nvPr/>
        </p:nvPicPr>
        <p:blipFill>
          <a:blip r:embed="rId16"/>
          <a:stretch/>
        </p:blipFill>
        <p:spPr>
          <a:xfrm>
            <a:off x="4584600" y="9167760"/>
            <a:ext cx="2346480" cy="1231920"/>
          </a:xfrm>
          <a:prstGeom prst="rect">
            <a:avLst/>
          </a:prstGeom>
          <a:ln w="0">
            <a:noFill/>
          </a:ln>
        </p:spPr>
      </p:pic>
      <p:pic>
        <p:nvPicPr>
          <p:cNvPr id="58" name="グラフ 18" descr=""/>
          <p:cNvPicPr/>
          <p:nvPr/>
        </p:nvPicPr>
        <p:blipFill>
          <a:blip r:embed="rId17"/>
          <a:stretch/>
        </p:blipFill>
        <p:spPr>
          <a:xfrm>
            <a:off x="201600" y="4376880"/>
            <a:ext cx="2346480" cy="1231920"/>
          </a:xfrm>
          <a:prstGeom prst="rect">
            <a:avLst/>
          </a:prstGeom>
          <a:ln w="0">
            <a:noFill/>
          </a:ln>
        </p:spPr>
      </p:pic>
      <p:grpSp>
        <p:nvGrpSpPr>
          <p:cNvPr id="59" name="グループ化 19"/>
          <p:cNvGrpSpPr/>
          <p:nvPr/>
        </p:nvGrpSpPr>
        <p:grpSpPr>
          <a:xfrm>
            <a:off x="4808880" y="2109240"/>
            <a:ext cx="2146320" cy="526680"/>
            <a:chOff x="4808880" y="2109240"/>
            <a:chExt cx="2146320" cy="526680"/>
          </a:xfrm>
        </p:grpSpPr>
        <p:sp>
          <p:nvSpPr>
            <p:cNvPr id="60" name="テキスト ボックス 20"/>
            <p:cNvSpPr/>
            <p:nvPr/>
          </p:nvSpPr>
          <p:spPr>
            <a:xfrm rot="17989800">
              <a:off x="4863960" y="219168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テキスト ボックス 21"/>
            <p:cNvSpPr/>
            <p:nvPr/>
          </p:nvSpPr>
          <p:spPr>
            <a:xfrm rot="17989800">
              <a:off x="4913640" y="223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テキスト ボックス 22"/>
            <p:cNvSpPr/>
            <p:nvPr/>
          </p:nvSpPr>
          <p:spPr>
            <a:xfrm rot="17989800">
              <a:off x="5072760" y="223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テキスト ボックス 23"/>
            <p:cNvSpPr/>
            <p:nvPr/>
          </p:nvSpPr>
          <p:spPr>
            <a:xfrm rot="17989800">
              <a:off x="5263920" y="223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テキスト ボックス 24"/>
            <p:cNvSpPr/>
            <p:nvPr/>
          </p:nvSpPr>
          <p:spPr>
            <a:xfrm rot="17989800">
              <a:off x="5454720" y="223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テキスト ボックス 25"/>
            <p:cNvSpPr/>
            <p:nvPr/>
          </p:nvSpPr>
          <p:spPr>
            <a:xfrm rot="17989800">
              <a:off x="5645880" y="223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テキスト ボックス 26"/>
            <p:cNvSpPr/>
            <p:nvPr/>
          </p:nvSpPr>
          <p:spPr>
            <a:xfrm rot="17989800">
              <a:off x="5799600" y="223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テキスト ボックス 27"/>
            <p:cNvSpPr/>
            <p:nvPr/>
          </p:nvSpPr>
          <p:spPr>
            <a:xfrm rot="17989800">
              <a:off x="5990400" y="223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テキスト ボックス 28"/>
            <p:cNvSpPr/>
            <p:nvPr/>
          </p:nvSpPr>
          <p:spPr>
            <a:xfrm rot="17989800">
              <a:off x="6346080" y="22334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テキスト ボックス 29"/>
            <p:cNvSpPr/>
            <p:nvPr/>
          </p:nvSpPr>
          <p:spPr>
            <a:xfrm rot="17989800">
              <a:off x="6177600" y="223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テキスト ボックス 30"/>
            <p:cNvSpPr/>
            <p:nvPr/>
          </p:nvSpPr>
          <p:spPr>
            <a:xfrm rot="17989800">
              <a:off x="6499800" y="22334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1" name="グループ化 31"/>
          <p:cNvGrpSpPr/>
          <p:nvPr/>
        </p:nvGrpSpPr>
        <p:grpSpPr>
          <a:xfrm>
            <a:off x="2638800" y="2109240"/>
            <a:ext cx="2131560" cy="526680"/>
            <a:chOff x="2638800" y="2109240"/>
            <a:chExt cx="2131560" cy="526680"/>
          </a:xfrm>
        </p:grpSpPr>
        <p:sp>
          <p:nvSpPr>
            <p:cNvPr id="72" name="テキスト ボックス 32"/>
            <p:cNvSpPr/>
            <p:nvPr/>
          </p:nvSpPr>
          <p:spPr>
            <a:xfrm rot="17989800">
              <a:off x="2693880" y="21913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テキスト ボックス 33"/>
            <p:cNvSpPr/>
            <p:nvPr/>
          </p:nvSpPr>
          <p:spPr>
            <a:xfrm rot="17989800">
              <a:off x="2742120" y="223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テキスト ボックス 34"/>
            <p:cNvSpPr/>
            <p:nvPr/>
          </p:nvSpPr>
          <p:spPr>
            <a:xfrm rot="17989800">
              <a:off x="2900160" y="223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テキスト ボックス 35"/>
            <p:cNvSpPr/>
            <p:nvPr/>
          </p:nvSpPr>
          <p:spPr>
            <a:xfrm rot="17989800">
              <a:off x="3089520" y="223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テキスト ボックス 36"/>
            <p:cNvSpPr/>
            <p:nvPr/>
          </p:nvSpPr>
          <p:spPr>
            <a:xfrm rot="17989800">
              <a:off x="3278880" y="223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テキスト ボックス 37"/>
            <p:cNvSpPr/>
            <p:nvPr/>
          </p:nvSpPr>
          <p:spPr>
            <a:xfrm rot="17989800">
              <a:off x="3468240" y="223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テキスト ボックス 38"/>
            <p:cNvSpPr/>
            <p:nvPr/>
          </p:nvSpPr>
          <p:spPr>
            <a:xfrm rot="17989800">
              <a:off x="3620520" y="223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テキスト ボックス 39"/>
            <p:cNvSpPr/>
            <p:nvPr/>
          </p:nvSpPr>
          <p:spPr>
            <a:xfrm rot="17989800">
              <a:off x="3809880" y="223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テキスト ボックス 40"/>
            <p:cNvSpPr/>
            <p:nvPr/>
          </p:nvSpPr>
          <p:spPr>
            <a:xfrm rot="17989800">
              <a:off x="4162680" y="22334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テキスト ボックス 41"/>
            <p:cNvSpPr/>
            <p:nvPr/>
          </p:nvSpPr>
          <p:spPr>
            <a:xfrm rot="17989800">
              <a:off x="3995280" y="223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テキスト ボックス 42"/>
            <p:cNvSpPr/>
            <p:nvPr/>
          </p:nvSpPr>
          <p:spPr>
            <a:xfrm rot="17989800">
              <a:off x="4314960" y="22334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3" name="グループ化 43"/>
          <p:cNvGrpSpPr/>
          <p:nvPr/>
        </p:nvGrpSpPr>
        <p:grpSpPr>
          <a:xfrm>
            <a:off x="427320" y="2111760"/>
            <a:ext cx="2113560" cy="526680"/>
            <a:chOff x="427320" y="2111760"/>
            <a:chExt cx="2113560" cy="526680"/>
          </a:xfrm>
        </p:grpSpPr>
        <p:sp>
          <p:nvSpPr>
            <p:cNvPr id="84" name="テキスト ボックス 44"/>
            <p:cNvSpPr/>
            <p:nvPr/>
          </p:nvSpPr>
          <p:spPr>
            <a:xfrm rot="17989800">
              <a:off x="482400" y="219456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テキスト ボックス 45"/>
            <p:cNvSpPr/>
            <p:nvPr/>
          </p:nvSpPr>
          <p:spPr>
            <a:xfrm rot="17989800">
              <a:off x="529560" y="22370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テキスト ボックス 46"/>
            <p:cNvSpPr/>
            <p:nvPr/>
          </p:nvSpPr>
          <p:spPr>
            <a:xfrm rot="17989800">
              <a:off x="685800" y="22370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テキスト ボックス 47"/>
            <p:cNvSpPr/>
            <p:nvPr/>
          </p:nvSpPr>
          <p:spPr>
            <a:xfrm rot="17989800">
              <a:off x="873000" y="22370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テキスト ボックス 48"/>
            <p:cNvSpPr/>
            <p:nvPr/>
          </p:nvSpPr>
          <p:spPr>
            <a:xfrm rot="17989800">
              <a:off x="1060560" y="22370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テキスト ボックス 49"/>
            <p:cNvSpPr/>
            <p:nvPr/>
          </p:nvSpPr>
          <p:spPr>
            <a:xfrm rot="17989800">
              <a:off x="1247760" y="22370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テキスト ボックス 50"/>
            <p:cNvSpPr/>
            <p:nvPr/>
          </p:nvSpPr>
          <p:spPr>
            <a:xfrm rot="17989800">
              <a:off x="1398600" y="22370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テキスト ボックス 51"/>
            <p:cNvSpPr/>
            <p:nvPr/>
          </p:nvSpPr>
          <p:spPr>
            <a:xfrm rot="17989800">
              <a:off x="1585800" y="22370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テキスト ボックス 52"/>
            <p:cNvSpPr/>
            <p:nvPr/>
          </p:nvSpPr>
          <p:spPr>
            <a:xfrm rot="17989800">
              <a:off x="1934640" y="22359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テキスト ボックス 53"/>
            <p:cNvSpPr/>
            <p:nvPr/>
          </p:nvSpPr>
          <p:spPr>
            <a:xfrm rot="17989800">
              <a:off x="1769400" y="22370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テキスト ボックス 54"/>
            <p:cNvSpPr/>
            <p:nvPr/>
          </p:nvSpPr>
          <p:spPr>
            <a:xfrm rot="17989800">
              <a:off x="2085480" y="22359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5" name="グループ化 55"/>
          <p:cNvGrpSpPr/>
          <p:nvPr/>
        </p:nvGrpSpPr>
        <p:grpSpPr>
          <a:xfrm>
            <a:off x="2638800" y="3710520"/>
            <a:ext cx="2131920" cy="526680"/>
            <a:chOff x="2638800" y="3710520"/>
            <a:chExt cx="2131920" cy="526680"/>
          </a:xfrm>
        </p:grpSpPr>
        <p:sp>
          <p:nvSpPr>
            <p:cNvPr id="96" name="テキスト ボックス 56"/>
            <p:cNvSpPr/>
            <p:nvPr/>
          </p:nvSpPr>
          <p:spPr>
            <a:xfrm rot="17989800">
              <a:off x="2693880" y="379296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テキスト ボックス 57"/>
            <p:cNvSpPr/>
            <p:nvPr/>
          </p:nvSpPr>
          <p:spPr>
            <a:xfrm rot="17989800">
              <a:off x="2742480" y="383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テキスト ボックス 58"/>
            <p:cNvSpPr/>
            <p:nvPr/>
          </p:nvSpPr>
          <p:spPr>
            <a:xfrm rot="17989800">
              <a:off x="2900520" y="383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テキスト ボックス 59"/>
            <p:cNvSpPr/>
            <p:nvPr/>
          </p:nvSpPr>
          <p:spPr>
            <a:xfrm rot="17989800">
              <a:off x="3089880" y="383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テキスト ボックス 60"/>
            <p:cNvSpPr/>
            <p:nvPr/>
          </p:nvSpPr>
          <p:spPr>
            <a:xfrm rot="17989800">
              <a:off x="3279240" y="383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テキスト ボックス 61"/>
            <p:cNvSpPr/>
            <p:nvPr/>
          </p:nvSpPr>
          <p:spPr>
            <a:xfrm rot="17989800">
              <a:off x="3468600" y="383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テキスト ボックス 62"/>
            <p:cNvSpPr/>
            <p:nvPr/>
          </p:nvSpPr>
          <p:spPr>
            <a:xfrm rot="17989800">
              <a:off x="3620880" y="383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テキスト ボックス 63"/>
            <p:cNvSpPr/>
            <p:nvPr/>
          </p:nvSpPr>
          <p:spPr>
            <a:xfrm rot="17989800">
              <a:off x="3810240" y="383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テキスト ボックス 64"/>
            <p:cNvSpPr/>
            <p:nvPr/>
          </p:nvSpPr>
          <p:spPr>
            <a:xfrm rot="17989800">
              <a:off x="4163040" y="38347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テキスト ボックス 65"/>
            <p:cNvSpPr/>
            <p:nvPr/>
          </p:nvSpPr>
          <p:spPr>
            <a:xfrm rot="17989800">
              <a:off x="3995640" y="383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テキスト ボックス 66"/>
            <p:cNvSpPr/>
            <p:nvPr/>
          </p:nvSpPr>
          <p:spPr>
            <a:xfrm rot="17989800">
              <a:off x="4315320" y="38347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7" name="グループ化 67"/>
          <p:cNvGrpSpPr/>
          <p:nvPr/>
        </p:nvGrpSpPr>
        <p:grpSpPr>
          <a:xfrm>
            <a:off x="451080" y="3711960"/>
            <a:ext cx="2115000" cy="526680"/>
            <a:chOff x="451080" y="3711960"/>
            <a:chExt cx="2115000" cy="526680"/>
          </a:xfrm>
        </p:grpSpPr>
        <p:sp>
          <p:nvSpPr>
            <p:cNvPr id="108" name="テキスト ボックス 68"/>
            <p:cNvSpPr/>
            <p:nvPr/>
          </p:nvSpPr>
          <p:spPr>
            <a:xfrm rot="17989800">
              <a:off x="506160" y="379476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テキスト ボックス 69"/>
            <p:cNvSpPr/>
            <p:nvPr/>
          </p:nvSpPr>
          <p:spPr>
            <a:xfrm rot="17989800">
              <a:off x="553320" y="383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テキスト ボックス 70"/>
            <p:cNvSpPr/>
            <p:nvPr/>
          </p:nvSpPr>
          <p:spPr>
            <a:xfrm rot="17989800">
              <a:off x="709560" y="383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テキスト ボックス 71"/>
            <p:cNvSpPr/>
            <p:nvPr/>
          </p:nvSpPr>
          <p:spPr>
            <a:xfrm rot="17989800">
              <a:off x="897120" y="383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テキスト ボックス 72"/>
            <p:cNvSpPr/>
            <p:nvPr/>
          </p:nvSpPr>
          <p:spPr>
            <a:xfrm rot="17989800">
              <a:off x="1084680" y="383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テキスト ボックス 73"/>
            <p:cNvSpPr/>
            <p:nvPr/>
          </p:nvSpPr>
          <p:spPr>
            <a:xfrm rot="17989800">
              <a:off x="1272240" y="383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テキスト ボックス 74"/>
            <p:cNvSpPr/>
            <p:nvPr/>
          </p:nvSpPr>
          <p:spPr>
            <a:xfrm rot="17989800">
              <a:off x="1423080" y="383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テキスト ボックス 75"/>
            <p:cNvSpPr/>
            <p:nvPr/>
          </p:nvSpPr>
          <p:spPr>
            <a:xfrm rot="17989800">
              <a:off x="1610280" y="383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テキスト ボックス 76"/>
            <p:cNvSpPr/>
            <p:nvPr/>
          </p:nvSpPr>
          <p:spPr>
            <a:xfrm rot="17989800">
              <a:off x="1959480" y="38361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テキスト ボックス 77"/>
            <p:cNvSpPr/>
            <p:nvPr/>
          </p:nvSpPr>
          <p:spPr>
            <a:xfrm rot="17989800">
              <a:off x="1793880" y="383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テキスト ボックス 78"/>
            <p:cNvSpPr/>
            <p:nvPr/>
          </p:nvSpPr>
          <p:spPr>
            <a:xfrm rot="17989800">
              <a:off x="2110680" y="38361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9" name="グループ化 79"/>
          <p:cNvGrpSpPr/>
          <p:nvPr/>
        </p:nvGrpSpPr>
        <p:grpSpPr>
          <a:xfrm>
            <a:off x="4808880" y="5350320"/>
            <a:ext cx="2146320" cy="526680"/>
            <a:chOff x="4808880" y="5350320"/>
            <a:chExt cx="2146320" cy="526680"/>
          </a:xfrm>
        </p:grpSpPr>
        <p:sp>
          <p:nvSpPr>
            <p:cNvPr id="120" name="テキスト ボックス 80"/>
            <p:cNvSpPr/>
            <p:nvPr/>
          </p:nvSpPr>
          <p:spPr>
            <a:xfrm rot="17989800">
              <a:off x="4863960" y="543276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テキスト ボックス 81"/>
            <p:cNvSpPr/>
            <p:nvPr/>
          </p:nvSpPr>
          <p:spPr>
            <a:xfrm rot="17989800">
              <a:off x="4913640" y="54756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テキスト ボックス 82"/>
            <p:cNvSpPr/>
            <p:nvPr/>
          </p:nvSpPr>
          <p:spPr>
            <a:xfrm rot="17989800">
              <a:off x="5072760" y="54756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テキスト ボックス 83"/>
            <p:cNvSpPr/>
            <p:nvPr/>
          </p:nvSpPr>
          <p:spPr>
            <a:xfrm rot="17989800">
              <a:off x="5263920" y="54756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テキスト ボックス 84"/>
            <p:cNvSpPr/>
            <p:nvPr/>
          </p:nvSpPr>
          <p:spPr>
            <a:xfrm rot="17989800">
              <a:off x="5454720" y="54756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テキスト ボックス 85"/>
            <p:cNvSpPr/>
            <p:nvPr/>
          </p:nvSpPr>
          <p:spPr>
            <a:xfrm rot="17989800">
              <a:off x="5645880" y="54756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テキスト ボックス 86"/>
            <p:cNvSpPr/>
            <p:nvPr/>
          </p:nvSpPr>
          <p:spPr>
            <a:xfrm rot="17989800">
              <a:off x="5799600" y="54756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テキスト ボックス 87"/>
            <p:cNvSpPr/>
            <p:nvPr/>
          </p:nvSpPr>
          <p:spPr>
            <a:xfrm rot="17989800">
              <a:off x="5990400" y="54756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テキスト ボックス 88"/>
            <p:cNvSpPr/>
            <p:nvPr/>
          </p:nvSpPr>
          <p:spPr>
            <a:xfrm rot="17989800">
              <a:off x="6346080" y="547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テキスト ボックス 89"/>
            <p:cNvSpPr/>
            <p:nvPr/>
          </p:nvSpPr>
          <p:spPr>
            <a:xfrm rot="17989800">
              <a:off x="6177600" y="54756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テキスト ボックス 90"/>
            <p:cNvSpPr/>
            <p:nvPr/>
          </p:nvSpPr>
          <p:spPr>
            <a:xfrm rot="17989800">
              <a:off x="6499800" y="547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31" name="グループ化 91"/>
          <p:cNvGrpSpPr/>
          <p:nvPr/>
        </p:nvGrpSpPr>
        <p:grpSpPr>
          <a:xfrm>
            <a:off x="2638800" y="5349960"/>
            <a:ext cx="2131560" cy="526680"/>
            <a:chOff x="2638800" y="5349960"/>
            <a:chExt cx="2131560" cy="526680"/>
          </a:xfrm>
        </p:grpSpPr>
        <p:sp>
          <p:nvSpPr>
            <p:cNvPr id="132" name="テキスト ボックス 92"/>
            <p:cNvSpPr/>
            <p:nvPr/>
          </p:nvSpPr>
          <p:spPr>
            <a:xfrm rot="17989800">
              <a:off x="2693880" y="543276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テキスト ボックス 93"/>
            <p:cNvSpPr/>
            <p:nvPr/>
          </p:nvSpPr>
          <p:spPr>
            <a:xfrm rot="17989800">
              <a:off x="2742120" y="5475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テキスト ボックス 94"/>
            <p:cNvSpPr/>
            <p:nvPr/>
          </p:nvSpPr>
          <p:spPr>
            <a:xfrm rot="17989800">
              <a:off x="2900160" y="5475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テキスト ボックス 95"/>
            <p:cNvSpPr/>
            <p:nvPr/>
          </p:nvSpPr>
          <p:spPr>
            <a:xfrm rot="17989800">
              <a:off x="3089520" y="5475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テキスト ボックス 96"/>
            <p:cNvSpPr/>
            <p:nvPr/>
          </p:nvSpPr>
          <p:spPr>
            <a:xfrm rot="17989800">
              <a:off x="3278880" y="5475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テキスト ボックス 97"/>
            <p:cNvSpPr/>
            <p:nvPr/>
          </p:nvSpPr>
          <p:spPr>
            <a:xfrm rot="17989800">
              <a:off x="3468240" y="5475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テキスト ボックス 98"/>
            <p:cNvSpPr/>
            <p:nvPr/>
          </p:nvSpPr>
          <p:spPr>
            <a:xfrm rot="17989800">
              <a:off x="3620520" y="5475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テキスト ボックス 99"/>
            <p:cNvSpPr/>
            <p:nvPr/>
          </p:nvSpPr>
          <p:spPr>
            <a:xfrm rot="17989800">
              <a:off x="3809880" y="5475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テキスト ボックス 100"/>
            <p:cNvSpPr/>
            <p:nvPr/>
          </p:nvSpPr>
          <p:spPr>
            <a:xfrm rot="17989800">
              <a:off x="4162680" y="54741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テキスト ボックス 101"/>
            <p:cNvSpPr/>
            <p:nvPr/>
          </p:nvSpPr>
          <p:spPr>
            <a:xfrm rot="17989800">
              <a:off x="3995280" y="5475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テキスト ボックス 102"/>
            <p:cNvSpPr/>
            <p:nvPr/>
          </p:nvSpPr>
          <p:spPr>
            <a:xfrm rot="17989800">
              <a:off x="4314960" y="54741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43" name="グループ化 103"/>
          <p:cNvGrpSpPr/>
          <p:nvPr/>
        </p:nvGrpSpPr>
        <p:grpSpPr>
          <a:xfrm>
            <a:off x="451080" y="5352480"/>
            <a:ext cx="2114640" cy="526680"/>
            <a:chOff x="451080" y="5352480"/>
            <a:chExt cx="2114640" cy="526680"/>
          </a:xfrm>
        </p:grpSpPr>
        <p:sp>
          <p:nvSpPr>
            <p:cNvPr id="144" name="テキスト ボックス 104"/>
            <p:cNvSpPr/>
            <p:nvPr/>
          </p:nvSpPr>
          <p:spPr>
            <a:xfrm rot="17989800">
              <a:off x="506160" y="54349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テキスト ボックス 105"/>
            <p:cNvSpPr/>
            <p:nvPr/>
          </p:nvSpPr>
          <p:spPr>
            <a:xfrm rot="17989800">
              <a:off x="552960" y="54777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テキスト ボックス 106"/>
            <p:cNvSpPr/>
            <p:nvPr/>
          </p:nvSpPr>
          <p:spPr>
            <a:xfrm rot="17989800">
              <a:off x="709200" y="54777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テキスト ボックス 107"/>
            <p:cNvSpPr/>
            <p:nvPr/>
          </p:nvSpPr>
          <p:spPr>
            <a:xfrm rot="17989800">
              <a:off x="896760" y="54777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テキスト ボックス 108"/>
            <p:cNvSpPr/>
            <p:nvPr/>
          </p:nvSpPr>
          <p:spPr>
            <a:xfrm rot="17989800">
              <a:off x="1084320" y="54777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テキスト ボックス 109"/>
            <p:cNvSpPr/>
            <p:nvPr/>
          </p:nvSpPr>
          <p:spPr>
            <a:xfrm rot="17989800">
              <a:off x="1271880" y="54777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テキスト ボックス 110"/>
            <p:cNvSpPr/>
            <p:nvPr/>
          </p:nvSpPr>
          <p:spPr>
            <a:xfrm rot="17989800">
              <a:off x="1422720" y="54777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テキスト ボックス 111"/>
            <p:cNvSpPr/>
            <p:nvPr/>
          </p:nvSpPr>
          <p:spPr>
            <a:xfrm rot="17989800">
              <a:off x="1609920" y="54777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テキスト ボックス 112"/>
            <p:cNvSpPr/>
            <p:nvPr/>
          </p:nvSpPr>
          <p:spPr>
            <a:xfrm rot="17989800">
              <a:off x="1959120" y="54766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テキスト ボックス 113"/>
            <p:cNvSpPr/>
            <p:nvPr/>
          </p:nvSpPr>
          <p:spPr>
            <a:xfrm rot="17989800">
              <a:off x="1793520" y="54777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テキスト ボックス 114"/>
            <p:cNvSpPr/>
            <p:nvPr/>
          </p:nvSpPr>
          <p:spPr>
            <a:xfrm rot="17989800">
              <a:off x="2110320" y="54766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55" name="グループ化 115"/>
          <p:cNvGrpSpPr/>
          <p:nvPr/>
        </p:nvGrpSpPr>
        <p:grpSpPr>
          <a:xfrm>
            <a:off x="4808880" y="6950520"/>
            <a:ext cx="2146680" cy="526680"/>
            <a:chOff x="4808880" y="6950520"/>
            <a:chExt cx="2146680" cy="526680"/>
          </a:xfrm>
        </p:grpSpPr>
        <p:sp>
          <p:nvSpPr>
            <p:cNvPr id="156" name="テキスト ボックス 116"/>
            <p:cNvSpPr/>
            <p:nvPr/>
          </p:nvSpPr>
          <p:spPr>
            <a:xfrm rot="17989800">
              <a:off x="4863960" y="70333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テキスト ボックス 117"/>
            <p:cNvSpPr/>
            <p:nvPr/>
          </p:nvSpPr>
          <p:spPr>
            <a:xfrm rot="17989800">
              <a:off x="4914000" y="707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テキスト ボックス 118"/>
            <p:cNvSpPr/>
            <p:nvPr/>
          </p:nvSpPr>
          <p:spPr>
            <a:xfrm rot="17989800">
              <a:off x="5073120" y="707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テキスト ボックス 119"/>
            <p:cNvSpPr/>
            <p:nvPr/>
          </p:nvSpPr>
          <p:spPr>
            <a:xfrm rot="17989800">
              <a:off x="5264280" y="707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テキスト ボックス 120"/>
            <p:cNvSpPr/>
            <p:nvPr/>
          </p:nvSpPr>
          <p:spPr>
            <a:xfrm rot="17989800">
              <a:off x="5455080" y="707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テキスト ボックス 121"/>
            <p:cNvSpPr/>
            <p:nvPr/>
          </p:nvSpPr>
          <p:spPr>
            <a:xfrm rot="17989800">
              <a:off x="5646240" y="707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テキスト ボックス 122"/>
            <p:cNvSpPr/>
            <p:nvPr/>
          </p:nvSpPr>
          <p:spPr>
            <a:xfrm rot="17989800">
              <a:off x="5799960" y="707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テキスト ボックス 123"/>
            <p:cNvSpPr/>
            <p:nvPr/>
          </p:nvSpPr>
          <p:spPr>
            <a:xfrm rot="17989800">
              <a:off x="5990760" y="707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テキスト ボックス 124"/>
            <p:cNvSpPr/>
            <p:nvPr/>
          </p:nvSpPr>
          <p:spPr>
            <a:xfrm rot="17989800">
              <a:off x="6346440" y="70747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テキスト ボックス 125"/>
            <p:cNvSpPr/>
            <p:nvPr/>
          </p:nvSpPr>
          <p:spPr>
            <a:xfrm rot="17989800">
              <a:off x="6177960" y="707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テキスト ボックス 126"/>
            <p:cNvSpPr/>
            <p:nvPr/>
          </p:nvSpPr>
          <p:spPr>
            <a:xfrm rot="17989800">
              <a:off x="6500160" y="70747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67" name="グループ化 127"/>
          <p:cNvGrpSpPr/>
          <p:nvPr/>
        </p:nvGrpSpPr>
        <p:grpSpPr>
          <a:xfrm>
            <a:off x="2638800" y="6950520"/>
            <a:ext cx="2131920" cy="526680"/>
            <a:chOff x="2638800" y="6950520"/>
            <a:chExt cx="2131920" cy="526680"/>
          </a:xfrm>
        </p:grpSpPr>
        <p:sp>
          <p:nvSpPr>
            <p:cNvPr id="168" name="テキスト ボックス 128"/>
            <p:cNvSpPr/>
            <p:nvPr/>
          </p:nvSpPr>
          <p:spPr>
            <a:xfrm rot="17989800">
              <a:off x="2693880" y="703296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テキスト ボックス 129"/>
            <p:cNvSpPr/>
            <p:nvPr/>
          </p:nvSpPr>
          <p:spPr>
            <a:xfrm rot="17989800">
              <a:off x="2742480" y="707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テキスト ボックス 130"/>
            <p:cNvSpPr/>
            <p:nvPr/>
          </p:nvSpPr>
          <p:spPr>
            <a:xfrm rot="17989800">
              <a:off x="2900520" y="707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テキスト ボックス 131"/>
            <p:cNvSpPr/>
            <p:nvPr/>
          </p:nvSpPr>
          <p:spPr>
            <a:xfrm rot="17989800">
              <a:off x="3089880" y="707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テキスト ボックス 132"/>
            <p:cNvSpPr/>
            <p:nvPr/>
          </p:nvSpPr>
          <p:spPr>
            <a:xfrm rot="17989800">
              <a:off x="3279240" y="707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テキスト ボックス 133"/>
            <p:cNvSpPr/>
            <p:nvPr/>
          </p:nvSpPr>
          <p:spPr>
            <a:xfrm rot="17989800">
              <a:off x="3468600" y="707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テキスト ボックス 134"/>
            <p:cNvSpPr/>
            <p:nvPr/>
          </p:nvSpPr>
          <p:spPr>
            <a:xfrm rot="17989800">
              <a:off x="3620880" y="707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テキスト ボックス 135"/>
            <p:cNvSpPr/>
            <p:nvPr/>
          </p:nvSpPr>
          <p:spPr>
            <a:xfrm rot="17989800">
              <a:off x="3810240" y="707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テキスト ボックス 136"/>
            <p:cNvSpPr/>
            <p:nvPr/>
          </p:nvSpPr>
          <p:spPr>
            <a:xfrm rot="17989800">
              <a:off x="4163040" y="70747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テキスト ボックス 137"/>
            <p:cNvSpPr/>
            <p:nvPr/>
          </p:nvSpPr>
          <p:spPr>
            <a:xfrm rot="17989800">
              <a:off x="3995640" y="7075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テキスト ボックス 138"/>
            <p:cNvSpPr/>
            <p:nvPr/>
          </p:nvSpPr>
          <p:spPr>
            <a:xfrm rot="17989800">
              <a:off x="4315320" y="70747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79" name="グループ化 139"/>
          <p:cNvGrpSpPr/>
          <p:nvPr/>
        </p:nvGrpSpPr>
        <p:grpSpPr>
          <a:xfrm>
            <a:off x="451080" y="6953760"/>
            <a:ext cx="2115000" cy="526680"/>
            <a:chOff x="451080" y="6953760"/>
            <a:chExt cx="2115000" cy="526680"/>
          </a:xfrm>
        </p:grpSpPr>
        <p:sp>
          <p:nvSpPr>
            <p:cNvPr id="180" name="テキスト ボックス 140"/>
            <p:cNvSpPr/>
            <p:nvPr/>
          </p:nvSpPr>
          <p:spPr>
            <a:xfrm rot="17989800">
              <a:off x="506160" y="703656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テキスト ボックス 141"/>
            <p:cNvSpPr/>
            <p:nvPr/>
          </p:nvSpPr>
          <p:spPr>
            <a:xfrm rot="17989800">
              <a:off x="553320" y="70790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テキスト ボックス 142"/>
            <p:cNvSpPr/>
            <p:nvPr/>
          </p:nvSpPr>
          <p:spPr>
            <a:xfrm rot="17989800">
              <a:off x="709560" y="70790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テキスト ボックス 143"/>
            <p:cNvSpPr/>
            <p:nvPr/>
          </p:nvSpPr>
          <p:spPr>
            <a:xfrm rot="17989800">
              <a:off x="897120" y="70790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テキスト ボックス 144"/>
            <p:cNvSpPr/>
            <p:nvPr/>
          </p:nvSpPr>
          <p:spPr>
            <a:xfrm rot="17989800">
              <a:off x="1084680" y="70790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テキスト ボックス 145"/>
            <p:cNvSpPr/>
            <p:nvPr/>
          </p:nvSpPr>
          <p:spPr>
            <a:xfrm rot="17989800">
              <a:off x="1272240" y="70790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テキスト ボックス 146"/>
            <p:cNvSpPr/>
            <p:nvPr/>
          </p:nvSpPr>
          <p:spPr>
            <a:xfrm rot="17989800">
              <a:off x="1423080" y="70790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テキスト ボックス 147"/>
            <p:cNvSpPr/>
            <p:nvPr/>
          </p:nvSpPr>
          <p:spPr>
            <a:xfrm rot="17989800">
              <a:off x="1610280" y="70790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テキスト ボックス 148"/>
            <p:cNvSpPr/>
            <p:nvPr/>
          </p:nvSpPr>
          <p:spPr>
            <a:xfrm rot="17989800">
              <a:off x="1959480" y="70779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テキスト ボックス 149"/>
            <p:cNvSpPr/>
            <p:nvPr/>
          </p:nvSpPr>
          <p:spPr>
            <a:xfrm rot="17989800">
              <a:off x="1793880" y="70790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テキスト ボックス 150"/>
            <p:cNvSpPr/>
            <p:nvPr/>
          </p:nvSpPr>
          <p:spPr>
            <a:xfrm rot="17989800">
              <a:off x="2110680" y="70779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91" name="グループ化 151"/>
          <p:cNvGrpSpPr/>
          <p:nvPr/>
        </p:nvGrpSpPr>
        <p:grpSpPr>
          <a:xfrm>
            <a:off x="4808880" y="8571960"/>
            <a:ext cx="2146320" cy="526680"/>
            <a:chOff x="4808880" y="8571960"/>
            <a:chExt cx="2146320" cy="526680"/>
          </a:xfrm>
        </p:grpSpPr>
        <p:sp>
          <p:nvSpPr>
            <p:cNvPr id="192" name="テキスト ボックス 152"/>
            <p:cNvSpPr/>
            <p:nvPr/>
          </p:nvSpPr>
          <p:spPr>
            <a:xfrm rot="17989800">
              <a:off x="4863960" y="86544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テキスト ボックス 153"/>
            <p:cNvSpPr/>
            <p:nvPr/>
          </p:nvSpPr>
          <p:spPr>
            <a:xfrm rot="17989800">
              <a:off x="4913640" y="869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テキスト ボックス 154"/>
            <p:cNvSpPr/>
            <p:nvPr/>
          </p:nvSpPr>
          <p:spPr>
            <a:xfrm rot="17989800">
              <a:off x="5072760" y="869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テキスト ボックス 155"/>
            <p:cNvSpPr/>
            <p:nvPr/>
          </p:nvSpPr>
          <p:spPr>
            <a:xfrm rot="17989800">
              <a:off x="5263920" y="869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テキスト ボックス 156"/>
            <p:cNvSpPr/>
            <p:nvPr/>
          </p:nvSpPr>
          <p:spPr>
            <a:xfrm rot="17989800">
              <a:off x="5454720" y="869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テキスト ボックス 157"/>
            <p:cNvSpPr/>
            <p:nvPr/>
          </p:nvSpPr>
          <p:spPr>
            <a:xfrm rot="17989800">
              <a:off x="5645880" y="869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テキスト ボックス 158"/>
            <p:cNvSpPr/>
            <p:nvPr/>
          </p:nvSpPr>
          <p:spPr>
            <a:xfrm rot="17989800">
              <a:off x="5799600" y="869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テキスト ボックス 159"/>
            <p:cNvSpPr/>
            <p:nvPr/>
          </p:nvSpPr>
          <p:spPr>
            <a:xfrm rot="17989800">
              <a:off x="5990400" y="869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テキスト ボックス 160"/>
            <p:cNvSpPr/>
            <p:nvPr/>
          </p:nvSpPr>
          <p:spPr>
            <a:xfrm rot="17989800">
              <a:off x="6346080" y="86961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テキスト ボックス 161"/>
            <p:cNvSpPr/>
            <p:nvPr/>
          </p:nvSpPr>
          <p:spPr>
            <a:xfrm rot="17989800">
              <a:off x="6177600" y="869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テキスト ボックス 162"/>
            <p:cNvSpPr/>
            <p:nvPr/>
          </p:nvSpPr>
          <p:spPr>
            <a:xfrm rot="17989800">
              <a:off x="6499800" y="86961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03" name="グループ化 163"/>
          <p:cNvGrpSpPr/>
          <p:nvPr/>
        </p:nvGrpSpPr>
        <p:grpSpPr>
          <a:xfrm>
            <a:off x="2638800" y="8571960"/>
            <a:ext cx="2131560" cy="526680"/>
            <a:chOff x="2638800" y="8571960"/>
            <a:chExt cx="2131560" cy="526680"/>
          </a:xfrm>
        </p:grpSpPr>
        <p:sp>
          <p:nvSpPr>
            <p:cNvPr id="204" name="テキスト ボックス 164"/>
            <p:cNvSpPr/>
            <p:nvPr/>
          </p:nvSpPr>
          <p:spPr>
            <a:xfrm rot="17989800">
              <a:off x="2693880" y="865404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テキスト ボックス 165"/>
            <p:cNvSpPr/>
            <p:nvPr/>
          </p:nvSpPr>
          <p:spPr>
            <a:xfrm rot="17989800">
              <a:off x="2742120" y="869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テキスト ボックス 166"/>
            <p:cNvSpPr/>
            <p:nvPr/>
          </p:nvSpPr>
          <p:spPr>
            <a:xfrm rot="17989800">
              <a:off x="2900160" y="869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テキスト ボックス 167"/>
            <p:cNvSpPr/>
            <p:nvPr/>
          </p:nvSpPr>
          <p:spPr>
            <a:xfrm rot="17989800">
              <a:off x="3089520" y="869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テキスト ボックス 168"/>
            <p:cNvSpPr/>
            <p:nvPr/>
          </p:nvSpPr>
          <p:spPr>
            <a:xfrm rot="17989800">
              <a:off x="3278880" y="869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テキスト ボックス 169"/>
            <p:cNvSpPr/>
            <p:nvPr/>
          </p:nvSpPr>
          <p:spPr>
            <a:xfrm rot="17989800">
              <a:off x="3468240" y="869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テキスト ボックス 170"/>
            <p:cNvSpPr/>
            <p:nvPr/>
          </p:nvSpPr>
          <p:spPr>
            <a:xfrm rot="17989800">
              <a:off x="3620520" y="869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テキスト ボックス 171"/>
            <p:cNvSpPr/>
            <p:nvPr/>
          </p:nvSpPr>
          <p:spPr>
            <a:xfrm rot="17989800">
              <a:off x="3809880" y="869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テキスト ボックス 172"/>
            <p:cNvSpPr/>
            <p:nvPr/>
          </p:nvSpPr>
          <p:spPr>
            <a:xfrm rot="17989800">
              <a:off x="4162680" y="86961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テキスト ボックス 173"/>
            <p:cNvSpPr/>
            <p:nvPr/>
          </p:nvSpPr>
          <p:spPr>
            <a:xfrm rot="17989800">
              <a:off x="3995280" y="86972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テキスト ボックス 174"/>
            <p:cNvSpPr/>
            <p:nvPr/>
          </p:nvSpPr>
          <p:spPr>
            <a:xfrm rot="17989800">
              <a:off x="4314960" y="86961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15" name="グループ化 175"/>
          <p:cNvGrpSpPr/>
          <p:nvPr/>
        </p:nvGrpSpPr>
        <p:grpSpPr>
          <a:xfrm>
            <a:off x="451080" y="8574480"/>
            <a:ext cx="2115000" cy="526680"/>
            <a:chOff x="451080" y="8574480"/>
            <a:chExt cx="2115000" cy="526680"/>
          </a:xfrm>
        </p:grpSpPr>
        <p:sp>
          <p:nvSpPr>
            <p:cNvPr id="216" name="テキスト ボックス 176"/>
            <p:cNvSpPr/>
            <p:nvPr/>
          </p:nvSpPr>
          <p:spPr>
            <a:xfrm rot="17989800">
              <a:off x="506160" y="865728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テキスト ボックス 177"/>
            <p:cNvSpPr/>
            <p:nvPr/>
          </p:nvSpPr>
          <p:spPr>
            <a:xfrm rot="17989800">
              <a:off x="553320" y="86997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テキスト ボックス 178"/>
            <p:cNvSpPr/>
            <p:nvPr/>
          </p:nvSpPr>
          <p:spPr>
            <a:xfrm rot="17989800">
              <a:off x="709560" y="86997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テキスト ボックス 179"/>
            <p:cNvSpPr/>
            <p:nvPr/>
          </p:nvSpPr>
          <p:spPr>
            <a:xfrm rot="17989800">
              <a:off x="897120" y="86997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テキスト ボックス 180"/>
            <p:cNvSpPr/>
            <p:nvPr/>
          </p:nvSpPr>
          <p:spPr>
            <a:xfrm rot="17989800">
              <a:off x="1084680" y="86997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テキスト ボックス 181"/>
            <p:cNvSpPr/>
            <p:nvPr/>
          </p:nvSpPr>
          <p:spPr>
            <a:xfrm rot="17989800">
              <a:off x="1272240" y="86997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テキスト ボックス 182"/>
            <p:cNvSpPr/>
            <p:nvPr/>
          </p:nvSpPr>
          <p:spPr>
            <a:xfrm rot="17989800">
              <a:off x="1423080" y="86997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テキスト ボックス 183"/>
            <p:cNvSpPr/>
            <p:nvPr/>
          </p:nvSpPr>
          <p:spPr>
            <a:xfrm rot="17989800">
              <a:off x="1610280" y="86997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テキスト ボックス 184"/>
            <p:cNvSpPr/>
            <p:nvPr/>
          </p:nvSpPr>
          <p:spPr>
            <a:xfrm rot="17989800">
              <a:off x="1959480" y="86986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テキスト ボックス 185"/>
            <p:cNvSpPr/>
            <p:nvPr/>
          </p:nvSpPr>
          <p:spPr>
            <a:xfrm rot="17989800">
              <a:off x="1793880" y="86997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テキスト ボックス 186"/>
            <p:cNvSpPr/>
            <p:nvPr/>
          </p:nvSpPr>
          <p:spPr>
            <a:xfrm rot="17989800">
              <a:off x="2110680" y="86986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27" name="グループ化 187"/>
          <p:cNvGrpSpPr/>
          <p:nvPr/>
        </p:nvGrpSpPr>
        <p:grpSpPr>
          <a:xfrm>
            <a:off x="4808880" y="10116000"/>
            <a:ext cx="2146680" cy="526680"/>
            <a:chOff x="4808880" y="10116000"/>
            <a:chExt cx="2146680" cy="526680"/>
          </a:xfrm>
        </p:grpSpPr>
        <p:sp>
          <p:nvSpPr>
            <p:cNvPr id="228" name="テキスト ボックス 188"/>
            <p:cNvSpPr/>
            <p:nvPr/>
          </p:nvSpPr>
          <p:spPr>
            <a:xfrm rot="17989800">
              <a:off x="4863960" y="101988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テキスト ボックス 189"/>
            <p:cNvSpPr/>
            <p:nvPr/>
          </p:nvSpPr>
          <p:spPr>
            <a:xfrm rot="17989800">
              <a:off x="4914000" y="102412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テキスト ボックス 190"/>
            <p:cNvSpPr/>
            <p:nvPr/>
          </p:nvSpPr>
          <p:spPr>
            <a:xfrm rot="17989800">
              <a:off x="5073120" y="102412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テキスト ボックス 191"/>
            <p:cNvSpPr/>
            <p:nvPr/>
          </p:nvSpPr>
          <p:spPr>
            <a:xfrm rot="17989800">
              <a:off x="5264280" y="102412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テキスト ボックス 192"/>
            <p:cNvSpPr/>
            <p:nvPr/>
          </p:nvSpPr>
          <p:spPr>
            <a:xfrm rot="17989800">
              <a:off x="5455080" y="102412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テキスト ボックス 193"/>
            <p:cNvSpPr/>
            <p:nvPr/>
          </p:nvSpPr>
          <p:spPr>
            <a:xfrm rot="17989800">
              <a:off x="5646240" y="102412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テキスト ボックス 194"/>
            <p:cNvSpPr/>
            <p:nvPr/>
          </p:nvSpPr>
          <p:spPr>
            <a:xfrm rot="17989800">
              <a:off x="5799960" y="102412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テキスト ボックス 195"/>
            <p:cNvSpPr/>
            <p:nvPr/>
          </p:nvSpPr>
          <p:spPr>
            <a:xfrm rot="17989800">
              <a:off x="5990760" y="102412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テキスト ボックス 196"/>
            <p:cNvSpPr/>
            <p:nvPr/>
          </p:nvSpPr>
          <p:spPr>
            <a:xfrm rot="17989800">
              <a:off x="6346440" y="102402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テキスト ボックス 197"/>
            <p:cNvSpPr/>
            <p:nvPr/>
          </p:nvSpPr>
          <p:spPr>
            <a:xfrm rot="17989800">
              <a:off x="6177960" y="102412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テキスト ボックス 198"/>
            <p:cNvSpPr/>
            <p:nvPr/>
          </p:nvSpPr>
          <p:spPr>
            <a:xfrm rot="17989800">
              <a:off x="6500160" y="102402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39" name="グループ化 199"/>
          <p:cNvGrpSpPr/>
          <p:nvPr/>
        </p:nvGrpSpPr>
        <p:grpSpPr>
          <a:xfrm>
            <a:off x="2638800" y="10116000"/>
            <a:ext cx="2131920" cy="526680"/>
            <a:chOff x="2638800" y="10116000"/>
            <a:chExt cx="2131920" cy="526680"/>
          </a:xfrm>
        </p:grpSpPr>
        <p:sp>
          <p:nvSpPr>
            <p:cNvPr id="240" name="テキスト ボックス 200"/>
            <p:cNvSpPr/>
            <p:nvPr/>
          </p:nvSpPr>
          <p:spPr>
            <a:xfrm rot="17989800">
              <a:off x="2693880" y="1019844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テキスト ボックス 201"/>
            <p:cNvSpPr/>
            <p:nvPr/>
          </p:nvSpPr>
          <p:spPr>
            <a:xfrm rot="17989800">
              <a:off x="2742480" y="102412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テキスト ボックス 202"/>
            <p:cNvSpPr/>
            <p:nvPr/>
          </p:nvSpPr>
          <p:spPr>
            <a:xfrm rot="17989800">
              <a:off x="2900520" y="102412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テキスト ボックス 203"/>
            <p:cNvSpPr/>
            <p:nvPr/>
          </p:nvSpPr>
          <p:spPr>
            <a:xfrm rot="17989800">
              <a:off x="3089880" y="102412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テキスト ボックス 204"/>
            <p:cNvSpPr/>
            <p:nvPr/>
          </p:nvSpPr>
          <p:spPr>
            <a:xfrm rot="17989800">
              <a:off x="3279240" y="102412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テキスト ボックス 205"/>
            <p:cNvSpPr/>
            <p:nvPr/>
          </p:nvSpPr>
          <p:spPr>
            <a:xfrm rot="17989800">
              <a:off x="3468600" y="102412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テキスト ボックス 206"/>
            <p:cNvSpPr/>
            <p:nvPr/>
          </p:nvSpPr>
          <p:spPr>
            <a:xfrm rot="17989800">
              <a:off x="3620880" y="102412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テキスト ボックス 207"/>
            <p:cNvSpPr/>
            <p:nvPr/>
          </p:nvSpPr>
          <p:spPr>
            <a:xfrm rot="17989800">
              <a:off x="3810240" y="102412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テキスト ボックス 208"/>
            <p:cNvSpPr/>
            <p:nvPr/>
          </p:nvSpPr>
          <p:spPr>
            <a:xfrm rot="17989800">
              <a:off x="4163040" y="102402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テキスト ボックス 209"/>
            <p:cNvSpPr/>
            <p:nvPr/>
          </p:nvSpPr>
          <p:spPr>
            <a:xfrm rot="17989800">
              <a:off x="3995640" y="1024128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テキスト ボックス 210"/>
            <p:cNvSpPr/>
            <p:nvPr/>
          </p:nvSpPr>
          <p:spPr>
            <a:xfrm rot="17989800">
              <a:off x="4315320" y="102402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51" name="グループ化 211"/>
          <p:cNvGrpSpPr/>
          <p:nvPr/>
        </p:nvGrpSpPr>
        <p:grpSpPr>
          <a:xfrm>
            <a:off x="451080" y="10119240"/>
            <a:ext cx="2115000" cy="526680"/>
            <a:chOff x="451080" y="10119240"/>
            <a:chExt cx="2115000" cy="526680"/>
          </a:xfrm>
        </p:grpSpPr>
        <p:sp>
          <p:nvSpPr>
            <p:cNvPr id="252" name="テキスト ボックス 212"/>
            <p:cNvSpPr/>
            <p:nvPr/>
          </p:nvSpPr>
          <p:spPr>
            <a:xfrm rot="17989800">
              <a:off x="506160" y="1020204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テキスト ボックス 213"/>
            <p:cNvSpPr/>
            <p:nvPr/>
          </p:nvSpPr>
          <p:spPr>
            <a:xfrm rot="17989800">
              <a:off x="553320" y="1024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テキスト ボックス 214"/>
            <p:cNvSpPr/>
            <p:nvPr/>
          </p:nvSpPr>
          <p:spPr>
            <a:xfrm rot="17989800">
              <a:off x="709560" y="1024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テキスト ボックス 215"/>
            <p:cNvSpPr/>
            <p:nvPr/>
          </p:nvSpPr>
          <p:spPr>
            <a:xfrm rot="17989800">
              <a:off x="897120" y="1024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テキスト ボックス 216"/>
            <p:cNvSpPr/>
            <p:nvPr/>
          </p:nvSpPr>
          <p:spPr>
            <a:xfrm rot="17989800">
              <a:off x="1084680" y="1024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テキスト ボックス 217"/>
            <p:cNvSpPr/>
            <p:nvPr/>
          </p:nvSpPr>
          <p:spPr>
            <a:xfrm rot="17989800">
              <a:off x="1272240" y="1024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テキスト ボックス 218"/>
            <p:cNvSpPr/>
            <p:nvPr/>
          </p:nvSpPr>
          <p:spPr>
            <a:xfrm rot="17989800">
              <a:off x="1423080" y="1024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テキスト ボックス 219"/>
            <p:cNvSpPr/>
            <p:nvPr/>
          </p:nvSpPr>
          <p:spPr>
            <a:xfrm rot="17989800">
              <a:off x="1610280" y="1024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テキスト ボックス 220"/>
            <p:cNvSpPr/>
            <p:nvPr/>
          </p:nvSpPr>
          <p:spPr>
            <a:xfrm rot="17989800">
              <a:off x="1959480" y="102434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テキスト ボックス 221"/>
            <p:cNvSpPr/>
            <p:nvPr/>
          </p:nvSpPr>
          <p:spPr>
            <a:xfrm rot="17989800">
              <a:off x="1793880" y="102445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テキスト ボックス 222"/>
            <p:cNvSpPr/>
            <p:nvPr/>
          </p:nvSpPr>
          <p:spPr>
            <a:xfrm rot="17989800">
              <a:off x="2110680" y="102434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63" name="テキスト ボックス 223"/>
          <p:cNvSpPr/>
          <p:nvPr/>
        </p:nvSpPr>
        <p:spPr>
          <a:xfrm>
            <a:off x="3002760" y="10431360"/>
            <a:ext cx="112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テキスト ボックス 224"/>
          <p:cNvSpPr/>
          <p:nvPr/>
        </p:nvSpPr>
        <p:spPr>
          <a:xfrm rot="16200000">
            <a:off x="-3436200" y="5482080"/>
            <a:ext cx="7078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oportion of change of NUPT length of original chloroplast regio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テキスト ボックス 225"/>
          <p:cNvSpPr/>
          <p:nvPr/>
        </p:nvSpPr>
        <p:spPr>
          <a:xfrm>
            <a:off x="4740120" y="71136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正方形/長方形 226"/>
          <p:cNvSpPr/>
          <p:nvPr/>
        </p:nvSpPr>
        <p:spPr>
          <a:xfrm>
            <a:off x="4654440" y="1265400"/>
            <a:ext cx="249480" cy="10648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正方形/長方形 227"/>
          <p:cNvSpPr/>
          <p:nvPr/>
        </p:nvSpPr>
        <p:spPr>
          <a:xfrm>
            <a:off x="2500200" y="1243080"/>
            <a:ext cx="250920" cy="10666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テキスト ボックス 228"/>
          <p:cNvSpPr/>
          <p:nvPr/>
        </p:nvSpPr>
        <p:spPr>
          <a:xfrm>
            <a:off x="2340000" y="1150920"/>
            <a:ext cx="49536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正方形/長方形 229"/>
          <p:cNvSpPr/>
          <p:nvPr/>
        </p:nvSpPr>
        <p:spPr>
          <a:xfrm>
            <a:off x="2492280" y="2863800"/>
            <a:ext cx="250920" cy="1065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正方形/長方形 230"/>
          <p:cNvSpPr/>
          <p:nvPr/>
        </p:nvSpPr>
        <p:spPr>
          <a:xfrm>
            <a:off x="303120" y="2863800"/>
            <a:ext cx="250920" cy="1065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正方形/長方形 231"/>
          <p:cNvSpPr/>
          <p:nvPr/>
        </p:nvSpPr>
        <p:spPr>
          <a:xfrm>
            <a:off x="298440" y="1208160"/>
            <a:ext cx="250920" cy="1065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正方形/長方形 232"/>
          <p:cNvSpPr/>
          <p:nvPr/>
        </p:nvSpPr>
        <p:spPr>
          <a:xfrm>
            <a:off x="2492280" y="4448160"/>
            <a:ext cx="250920" cy="1065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正方形/長方形 233"/>
          <p:cNvSpPr/>
          <p:nvPr/>
        </p:nvSpPr>
        <p:spPr>
          <a:xfrm>
            <a:off x="298440" y="4448160"/>
            <a:ext cx="250920" cy="1065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正方形/長方形 234"/>
          <p:cNvSpPr/>
          <p:nvPr/>
        </p:nvSpPr>
        <p:spPr>
          <a:xfrm>
            <a:off x="4680000" y="4448160"/>
            <a:ext cx="249120" cy="1065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正方形/長方形 235"/>
          <p:cNvSpPr/>
          <p:nvPr/>
        </p:nvSpPr>
        <p:spPr>
          <a:xfrm>
            <a:off x="2484360" y="6032520"/>
            <a:ext cx="249480" cy="1065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正方形/長方形 236"/>
          <p:cNvSpPr/>
          <p:nvPr/>
        </p:nvSpPr>
        <p:spPr>
          <a:xfrm>
            <a:off x="324000" y="6032520"/>
            <a:ext cx="249120" cy="1065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正方形/長方形 237"/>
          <p:cNvSpPr/>
          <p:nvPr/>
        </p:nvSpPr>
        <p:spPr>
          <a:xfrm>
            <a:off x="4691160" y="6032520"/>
            <a:ext cx="250560" cy="1065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正方形/長方形 238"/>
          <p:cNvSpPr/>
          <p:nvPr/>
        </p:nvSpPr>
        <p:spPr>
          <a:xfrm>
            <a:off x="2484360" y="7674120"/>
            <a:ext cx="249480" cy="1065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正方形/長方形 239"/>
          <p:cNvSpPr/>
          <p:nvPr/>
        </p:nvSpPr>
        <p:spPr>
          <a:xfrm>
            <a:off x="324000" y="7674120"/>
            <a:ext cx="249120" cy="1065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正方形/長方形 240"/>
          <p:cNvSpPr/>
          <p:nvPr/>
        </p:nvSpPr>
        <p:spPr>
          <a:xfrm>
            <a:off x="4686480" y="7674120"/>
            <a:ext cx="250560" cy="1065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正方形/長方形 241"/>
          <p:cNvSpPr/>
          <p:nvPr/>
        </p:nvSpPr>
        <p:spPr>
          <a:xfrm>
            <a:off x="2489040" y="9258480"/>
            <a:ext cx="249480" cy="10648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正方形/長方形 242"/>
          <p:cNvSpPr/>
          <p:nvPr/>
        </p:nvSpPr>
        <p:spPr>
          <a:xfrm>
            <a:off x="328680" y="9258480"/>
            <a:ext cx="249120" cy="10648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正方形/長方形 243"/>
          <p:cNvSpPr/>
          <p:nvPr/>
        </p:nvSpPr>
        <p:spPr>
          <a:xfrm>
            <a:off x="4691160" y="9258480"/>
            <a:ext cx="250560" cy="10648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テキスト ボックス 244"/>
          <p:cNvSpPr/>
          <p:nvPr/>
        </p:nvSpPr>
        <p:spPr>
          <a:xfrm>
            <a:off x="125280" y="1146240"/>
            <a:ext cx="495360" cy="123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3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テキスト ボックス 245"/>
          <p:cNvSpPr/>
          <p:nvPr/>
        </p:nvSpPr>
        <p:spPr>
          <a:xfrm>
            <a:off x="4535640" y="1139760"/>
            <a:ext cx="49500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テキスト ボックス 246"/>
          <p:cNvSpPr/>
          <p:nvPr/>
        </p:nvSpPr>
        <p:spPr>
          <a:xfrm>
            <a:off x="189000" y="2716200"/>
            <a:ext cx="49536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テキスト ボックス 247"/>
          <p:cNvSpPr/>
          <p:nvPr/>
        </p:nvSpPr>
        <p:spPr>
          <a:xfrm>
            <a:off x="2384280" y="2705040"/>
            <a:ext cx="49536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テキスト ボックス 248"/>
          <p:cNvSpPr/>
          <p:nvPr/>
        </p:nvSpPr>
        <p:spPr>
          <a:xfrm>
            <a:off x="2349360" y="4379760"/>
            <a:ext cx="49536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テキスト ボックス 249"/>
          <p:cNvSpPr/>
          <p:nvPr/>
        </p:nvSpPr>
        <p:spPr>
          <a:xfrm>
            <a:off x="4554360" y="4362480"/>
            <a:ext cx="49536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テキスト ボックス 250"/>
          <p:cNvSpPr/>
          <p:nvPr/>
        </p:nvSpPr>
        <p:spPr>
          <a:xfrm>
            <a:off x="2376360" y="5956200"/>
            <a:ext cx="49536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テキスト ボックス 251"/>
          <p:cNvSpPr/>
          <p:nvPr/>
        </p:nvSpPr>
        <p:spPr>
          <a:xfrm>
            <a:off x="4554360" y="5945040"/>
            <a:ext cx="49536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テキスト ボックス 252"/>
          <p:cNvSpPr/>
          <p:nvPr/>
        </p:nvSpPr>
        <p:spPr>
          <a:xfrm>
            <a:off x="189000" y="5964120"/>
            <a:ext cx="49536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テキスト ボックス 253"/>
          <p:cNvSpPr/>
          <p:nvPr/>
        </p:nvSpPr>
        <p:spPr>
          <a:xfrm>
            <a:off x="2376360" y="7612200"/>
            <a:ext cx="49536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テキスト ボックス 254"/>
          <p:cNvSpPr/>
          <p:nvPr/>
        </p:nvSpPr>
        <p:spPr>
          <a:xfrm>
            <a:off x="4554360" y="7602480"/>
            <a:ext cx="49536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テキスト ボックス 255"/>
          <p:cNvSpPr/>
          <p:nvPr/>
        </p:nvSpPr>
        <p:spPr>
          <a:xfrm>
            <a:off x="189000" y="7621560"/>
            <a:ext cx="49536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テキスト ボックス 256"/>
          <p:cNvSpPr/>
          <p:nvPr/>
        </p:nvSpPr>
        <p:spPr>
          <a:xfrm>
            <a:off x="2376360" y="9163080"/>
            <a:ext cx="49536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テキスト ボックス 257"/>
          <p:cNvSpPr/>
          <p:nvPr/>
        </p:nvSpPr>
        <p:spPr>
          <a:xfrm>
            <a:off x="4554360" y="9151920"/>
            <a:ext cx="49536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テキスト ボックス 258"/>
          <p:cNvSpPr/>
          <p:nvPr/>
        </p:nvSpPr>
        <p:spPr>
          <a:xfrm>
            <a:off x="189000" y="9171000"/>
            <a:ext cx="495360" cy="12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テキスト ボックス 259"/>
          <p:cNvSpPr/>
          <p:nvPr/>
        </p:nvSpPr>
        <p:spPr>
          <a:xfrm>
            <a:off x="115920" y="4379760"/>
            <a:ext cx="496800" cy="11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0.04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22T10:55:17Z</dcterms:created>
  <dc:creator>FURIHATA</dc:creator>
  <dc:description/>
  <dc:language>en-US</dc:language>
  <cp:lastModifiedBy>kawabe</cp:lastModifiedBy>
  <dcterms:modified xsi:type="dcterms:W3CDTF">2013-09-26T07:42:52Z</dcterms:modified>
  <cp:revision>4</cp:revision>
  <dc:subject/>
  <dc:title>PowerPoint プレゼンテーション</dc:title>
</cp:coreProperties>
</file>